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1" r:id="rId3"/>
    <p:sldId id="256" r:id="rId4"/>
    <p:sldId id="257" r:id="rId5"/>
    <p:sldId id="258" r:id="rId6"/>
    <p:sldId id="259" r:id="rId7"/>
    <p:sldId id="260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>
        <p:scale>
          <a:sx n="90" d="100"/>
          <a:sy n="90" d="100"/>
        </p:scale>
        <p:origin x="-216" y="-94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6BB9A7-44DD-4E2F-B3A4-841D3F04537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577D7AC-3CB7-43B3-8A4A-06A9199179F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6C2C65-DA85-4E7F-97E0-EDF8BB5EEE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1BC0A-4888-43B8-A181-81D22E69E331}" type="datetimeFigureOut">
              <a:rPr lang="en-US" smtClean="0"/>
              <a:t>10/1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1AB301-6E4A-4CF0-A85D-BFC8ABD7FA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5829C7-1C5B-461D-A853-E7EF78873B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0E959-F01D-4098-BCED-C8D6BA3424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88445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D5804E-F902-469D-AA2D-984ED8CD66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79EB455-8F05-4A68-B8FB-2B8E6E44E7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6D5D0D-5D6F-4818-A607-295C1DE773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1BC0A-4888-43B8-A181-81D22E69E331}" type="datetimeFigureOut">
              <a:rPr lang="en-US" smtClean="0"/>
              <a:t>10/1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125BE2-3EBB-482B-A386-A27C4AE181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C9E246-EAE3-4BCF-9349-FA7A08D787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0E959-F01D-4098-BCED-C8D6BA3424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20444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9477228-3C93-478E-993F-758E17C4D95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F7DD95-C2A3-434F-847A-7BBB5C644F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F3C027-42BF-499A-9EDB-53A799BC97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1BC0A-4888-43B8-A181-81D22E69E331}" type="datetimeFigureOut">
              <a:rPr lang="en-US" smtClean="0"/>
              <a:t>10/1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53AF17-81DA-41C7-898B-D97856D538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3A9AF6-C19E-447D-9785-141CB7F6E8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0E959-F01D-4098-BCED-C8D6BA3424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71094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820FD1-6B39-4595-B170-5C4E91E8C7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7FD64A-02EC-4D9D-B145-628AD194AA5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702ADD-8E1F-4D36-A8DB-5ACD01294D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1BC0A-4888-43B8-A181-81D22E69E331}" type="datetimeFigureOut">
              <a:rPr lang="en-US" smtClean="0"/>
              <a:t>10/1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A073BD-F295-45BA-BB04-8D4E657357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CEBF8F-A8AA-4F44-A2DE-5AD97E44E4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0E959-F01D-4098-BCED-C8D6BA3424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71632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25BADE-3777-477C-8835-6303B5C3D8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0FCB269-8DAA-49EE-99A3-0199E118BC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4E97C5-43EC-432E-8604-223A419247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1BC0A-4888-43B8-A181-81D22E69E331}" type="datetimeFigureOut">
              <a:rPr lang="en-US" smtClean="0"/>
              <a:t>10/1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D0EB42-4620-451C-8B04-ED31211DDA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C565E5-5018-48E2-9F76-66FC584C67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0E959-F01D-4098-BCED-C8D6BA3424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62421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00BEDC-400F-4C71-9789-20A8E103D1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1DE422-97F6-42F7-AFFA-B065C677FE4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9CB5D64-BB3A-4F81-AE19-C233AA233B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8D72790-552C-43B7-BCD9-F4984378B5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1BC0A-4888-43B8-A181-81D22E69E331}" type="datetimeFigureOut">
              <a:rPr lang="en-US" smtClean="0"/>
              <a:t>10/1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72AFAD-E4CA-4F01-82D1-31093D1AEE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830330A-5008-4420-B61C-FCAEB09E2E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0E959-F01D-4098-BCED-C8D6BA3424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105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507976-E616-4D6C-B85C-B0C352A7B9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250797-417D-4837-B657-16D440B690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D75FAA6-EC50-45CE-BFE1-0463354860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64BA0E8-F8C1-41A1-A67B-114F910B88C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48AFA8B-A7FA-4FA9-954D-E76B3F9F350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1B2B594-F15E-42F1-A4DA-F961280179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1BC0A-4888-43B8-A181-81D22E69E331}" type="datetimeFigureOut">
              <a:rPr lang="en-US" smtClean="0"/>
              <a:t>10/16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7146DB5-5CD5-482E-B426-119021EF27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64892D0-D120-4135-8EDE-8579DB099D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0E959-F01D-4098-BCED-C8D6BA3424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37724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46BC36-4D80-4207-860B-DC2BA63992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4D479CE-0C36-40C3-B496-5BCD9F10B1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1BC0A-4888-43B8-A181-81D22E69E331}" type="datetimeFigureOut">
              <a:rPr lang="en-US" smtClean="0"/>
              <a:t>10/16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C34DD5D-C7C0-4279-AE10-5E76BC1C48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D981421-FB01-43A2-8D74-2DECEB56CD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0E959-F01D-4098-BCED-C8D6BA3424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2375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52F4A1A-306E-4EB6-B0FE-DB2C36FA91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1BC0A-4888-43B8-A181-81D22E69E331}" type="datetimeFigureOut">
              <a:rPr lang="en-US" smtClean="0"/>
              <a:t>10/16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C96A692-87CF-4036-9A73-9DC5E94C0E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B34FFF4-62B2-4107-A8CA-EF8B3088A1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0E959-F01D-4098-BCED-C8D6BA3424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66738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E0A088-8AA3-4120-8AD0-C2F88EF0EA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E9216F9-CFDC-46CF-A55B-4F04443AE8E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5FEDD37-F0ED-4207-949F-CC2924C5558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317ED2-CBE1-4732-9EDC-385B099CFB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1BC0A-4888-43B8-A181-81D22E69E331}" type="datetimeFigureOut">
              <a:rPr lang="en-US" smtClean="0"/>
              <a:t>10/1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12F06D5-3535-4C56-B17B-C597AA4BCD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E35697-96CA-4310-AC49-CE95D90CD1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0E959-F01D-4098-BCED-C8D6BA3424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05713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1C7AE5-7EAF-465D-A2AD-B617609084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AD3D908-7827-42B1-B46D-CAF3989D96A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F8093AF-387C-454A-83CD-B0CF73D1DB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A6A6CF5-0CB4-4155-A45A-AF17F0CF55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21BC0A-4888-43B8-A181-81D22E69E331}" type="datetimeFigureOut">
              <a:rPr lang="en-US" smtClean="0"/>
              <a:t>10/1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6DF34E7-C380-447F-B69E-8ECC953CEF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C200B0-474A-4C13-8EBB-B1C816A85F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0E959-F01D-4098-BCED-C8D6BA3424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2805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B4CB80A-C7A0-4E96-ABD0-961D00D517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0F2845-52E8-42DC-BD13-55A1CF3853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481E20-3A74-482F-8D7C-54DC033BF4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21BC0A-4888-43B8-A181-81D22E69E331}" type="datetimeFigureOut">
              <a:rPr lang="en-US" smtClean="0"/>
              <a:t>10/1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492F1A-F374-4DFA-8826-BD6C375EC3B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A2C79D-83BC-460D-9429-27A7020B977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A0E959-F01D-4098-BCED-C8D6BA3424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719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>
            <a:extLst>
              <a:ext uri="{FF2B5EF4-FFF2-40B4-BE49-F238E27FC236}">
                <a16:creationId xmlns:a16="http://schemas.microsoft.com/office/drawing/2014/main" id="{4FA8749A-0C10-4EF4-9B4B-7B2A14C6E308}"/>
              </a:ext>
            </a:extLst>
          </p:cNvPr>
          <p:cNvSpPr/>
          <p:nvPr/>
        </p:nvSpPr>
        <p:spPr>
          <a:xfrm>
            <a:off x="1020726" y="6018028"/>
            <a:ext cx="8910083" cy="552893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ysClr val="windowText" lastClr="000000"/>
                </a:solidFill>
              </a:ln>
            </a:endParaRP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2CCB38AB-C7AE-45EA-AB1E-4C0CB90D34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76745" y="6134986"/>
            <a:ext cx="10515600" cy="282246"/>
          </a:xfrm>
        </p:spPr>
        <p:txBody>
          <a:bodyPr>
            <a:noAutofit/>
          </a:bodyPr>
          <a:lstStyle/>
          <a:p>
            <a:r>
              <a:rPr lang="en-US" sz="2000" dirty="0"/>
              <a:t>Figure S1|Boxplot summarizing the vegetative growth parameters in the two locations</a:t>
            </a:r>
          </a:p>
        </p:txBody>
      </p:sp>
      <p:pic>
        <p:nvPicPr>
          <p:cNvPr id="9" name="Content Placeholder 8">
            <a:extLst>
              <a:ext uri="{FF2B5EF4-FFF2-40B4-BE49-F238E27FC236}">
                <a16:creationId xmlns:a16="http://schemas.microsoft.com/office/drawing/2014/main" id="{A36CCA7C-D5AB-4FD8-8BED-F6B205D777D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201"/>
          <a:stretch/>
        </p:blipFill>
        <p:spPr>
          <a:xfrm>
            <a:off x="1244602" y="449071"/>
            <a:ext cx="9313528" cy="5175552"/>
          </a:xfr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8506992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8B728360-CEE0-418D-8F61-7619E8BF05BD}"/>
              </a:ext>
            </a:extLst>
          </p:cNvPr>
          <p:cNvSpPr/>
          <p:nvPr/>
        </p:nvSpPr>
        <p:spPr>
          <a:xfrm>
            <a:off x="978196" y="5954233"/>
            <a:ext cx="7198242" cy="457200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5B5813D2-48EB-4F12-AA3E-8DB7C1A194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49036" y="5954234"/>
            <a:ext cx="10515600" cy="457200"/>
          </a:xfrm>
        </p:spPr>
        <p:txBody>
          <a:bodyPr>
            <a:normAutofit/>
          </a:bodyPr>
          <a:lstStyle/>
          <a:p>
            <a:r>
              <a:rPr lang="en-US" sz="1800" dirty="0"/>
              <a:t>Figure S2|Boxplot summarizing the yield and yield traits in the two locations</a:t>
            </a:r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4444560F-6FE5-4075-A4E4-B5B2A99B73D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0325" y="514366"/>
            <a:ext cx="9424164" cy="5174052"/>
          </a:xfr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3574070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Content Placeholder 6">
            <a:extLst>
              <a:ext uri="{FF2B5EF4-FFF2-40B4-BE49-F238E27FC236}">
                <a16:creationId xmlns:a16="http://schemas.microsoft.com/office/drawing/2014/main" id="{5FF60AE3-E5D4-4886-8977-A555C035335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3137" y="306026"/>
            <a:ext cx="7400925" cy="4314825"/>
          </a:xfrm>
          <a:ln>
            <a:solidFill>
              <a:schemeClr val="tx1"/>
            </a:solidFill>
          </a:ln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309E0A3C-198E-40B2-A9F8-756073D0BCC9}"/>
              </a:ext>
            </a:extLst>
          </p:cNvPr>
          <p:cNvSpPr/>
          <p:nvPr/>
        </p:nvSpPr>
        <p:spPr>
          <a:xfrm>
            <a:off x="2258291" y="5140036"/>
            <a:ext cx="7453746" cy="90054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dirty="0">
                <a:solidFill>
                  <a:schemeClr val="tx1"/>
                </a:solidFill>
              </a:rPr>
              <a:t>Figure S3| Variable contributions to dimension 1</a:t>
            </a:r>
          </a:p>
        </p:txBody>
      </p:sp>
    </p:spTree>
    <p:extLst>
      <p:ext uri="{BB962C8B-B14F-4D97-AF65-F5344CB8AC3E}">
        <p14:creationId xmlns:p14="http://schemas.microsoft.com/office/powerpoint/2010/main" val="3742700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CBA7970E-7AC2-454D-9FB9-5331313847B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0119" y="680099"/>
            <a:ext cx="7400925" cy="4314825"/>
          </a:xfrm>
          <a:ln>
            <a:solidFill>
              <a:schemeClr val="tx1"/>
            </a:solidFill>
          </a:ln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148D8775-800C-4C1A-A3C5-F5093FC0B98F}"/>
              </a:ext>
            </a:extLst>
          </p:cNvPr>
          <p:cNvSpPr/>
          <p:nvPr/>
        </p:nvSpPr>
        <p:spPr>
          <a:xfrm>
            <a:off x="2299856" y="5403275"/>
            <a:ext cx="7453746" cy="90054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dirty="0">
                <a:solidFill>
                  <a:schemeClr val="tx1"/>
                </a:solidFill>
              </a:rPr>
              <a:t>Figure S4| Variable contributions to dimension 2</a:t>
            </a:r>
          </a:p>
        </p:txBody>
      </p:sp>
    </p:spTree>
    <p:extLst>
      <p:ext uri="{BB962C8B-B14F-4D97-AF65-F5344CB8AC3E}">
        <p14:creationId xmlns:p14="http://schemas.microsoft.com/office/powerpoint/2010/main" val="5593352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9CE1130D-9EA9-4FBA-BE2E-F23D81F2A12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3246" y="707808"/>
            <a:ext cx="7400925" cy="4314825"/>
          </a:xfrm>
          <a:ln>
            <a:solidFill>
              <a:schemeClr val="tx1"/>
            </a:solidFill>
          </a:ln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AF85CB82-AC1D-4DD3-8D53-EE1166C5CC2A}"/>
              </a:ext>
            </a:extLst>
          </p:cNvPr>
          <p:cNvSpPr/>
          <p:nvPr/>
        </p:nvSpPr>
        <p:spPr>
          <a:xfrm>
            <a:off x="2382982" y="5514109"/>
            <a:ext cx="7453746" cy="90054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dirty="0">
                <a:solidFill>
                  <a:schemeClr val="tx1"/>
                </a:solidFill>
              </a:rPr>
              <a:t>Figure S5| Variable contributions to dimension 3</a:t>
            </a:r>
          </a:p>
        </p:txBody>
      </p:sp>
    </p:spTree>
    <p:extLst>
      <p:ext uri="{BB962C8B-B14F-4D97-AF65-F5344CB8AC3E}">
        <p14:creationId xmlns:p14="http://schemas.microsoft.com/office/powerpoint/2010/main" val="4701412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CBEC41B3-92EC-4682-9DDD-FB7B23059B9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5711" y="380358"/>
            <a:ext cx="5403272" cy="4942018"/>
          </a:xfrm>
          <a:ln>
            <a:solidFill>
              <a:schemeClr val="tx1"/>
            </a:solidFill>
          </a:ln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1D2002B3-C44C-4680-A2D5-095E0D474EA4}"/>
              </a:ext>
            </a:extLst>
          </p:cNvPr>
          <p:cNvSpPr/>
          <p:nvPr/>
        </p:nvSpPr>
        <p:spPr>
          <a:xfrm>
            <a:off x="4184073" y="5569527"/>
            <a:ext cx="3643746" cy="90054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Figure S6| Variable PCA</a:t>
            </a:r>
          </a:p>
        </p:txBody>
      </p:sp>
    </p:spTree>
    <p:extLst>
      <p:ext uri="{BB962C8B-B14F-4D97-AF65-F5344CB8AC3E}">
        <p14:creationId xmlns:p14="http://schemas.microsoft.com/office/powerpoint/2010/main" val="300017855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CE77AC92-80BD-4654-A426-4E29EDA86CC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0214" y="415637"/>
            <a:ext cx="8176374" cy="5093134"/>
          </a:xfrm>
          <a:ln>
            <a:solidFill>
              <a:schemeClr val="tx1"/>
            </a:solidFill>
          </a:ln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48D15502-F763-4815-BFA7-57E5B73C85B7}"/>
              </a:ext>
            </a:extLst>
          </p:cNvPr>
          <p:cNvSpPr/>
          <p:nvPr/>
        </p:nvSpPr>
        <p:spPr>
          <a:xfrm>
            <a:off x="4197927" y="5791200"/>
            <a:ext cx="4641274" cy="90054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Figure S7| Individual PCA</a:t>
            </a:r>
          </a:p>
        </p:txBody>
      </p:sp>
    </p:spTree>
    <p:extLst>
      <p:ext uri="{BB962C8B-B14F-4D97-AF65-F5344CB8AC3E}">
        <p14:creationId xmlns:p14="http://schemas.microsoft.com/office/powerpoint/2010/main" val="15659030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0</TotalTime>
  <Words>61</Words>
  <Application>Microsoft Office PowerPoint</Application>
  <PresentationFormat>Widescreen</PresentationFormat>
  <Paragraphs>7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Figure S1|Boxplot summarizing the vegetative growth parameters in the two locations</vt:lpstr>
      <vt:lpstr>Figure S2|Boxplot summarizing the yield and yield traits in the two locations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luwaseyi olanrewaju</dc:creator>
  <cp:lastModifiedBy>oluwaseyi olanrewaju</cp:lastModifiedBy>
  <cp:revision>7</cp:revision>
  <dcterms:created xsi:type="dcterms:W3CDTF">2021-07-23T22:51:50Z</dcterms:created>
  <dcterms:modified xsi:type="dcterms:W3CDTF">2021-10-16T11:34:16Z</dcterms:modified>
</cp:coreProperties>
</file>